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8" r:id="rId2"/>
  </p:sldIdLst>
  <p:sldSz cx="6858000" cy="9144000" type="screen4x3"/>
  <p:notesSz cx="666273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5759">
          <p15:clr>
            <a:srgbClr val="A4A3A4"/>
          </p15:clr>
        </p15:guide>
        <p15:guide id="2" pos="30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6" d="100"/>
          <a:sy n="86" d="100"/>
        </p:scale>
        <p:origin x="-2054" y="518"/>
      </p:cViewPr>
      <p:guideLst>
        <p:guide orient="horz" pos="5759"/>
        <p:guide pos="306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91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773270" y="0"/>
            <a:ext cx="288791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490596-58E7-4D6E-958B-413060BA94A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8164"/>
            <a:ext cx="288791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773270" y="9428164"/>
            <a:ext cx="288791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01A29F-6187-4245-8620-1D8B6571A2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410187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D76CE4-F2EA-48AF-988E-F9A3F555EA3E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36750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2923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766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3488" y="9428163"/>
            <a:ext cx="2887662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D1EFAF-EFE9-482B-BB84-79191498903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32280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7042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5365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6377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1453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2880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8406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9281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497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9119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8787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248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9716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00" y="3240000"/>
            <a:ext cx="3510000" cy="2217600"/>
          </a:xfrm>
          <a:prstGeom prst="rect">
            <a:avLst/>
          </a:prstGeom>
        </p:spPr>
      </p:pic>
      <p:pic>
        <p:nvPicPr>
          <p:cNvPr id="6" name="Grafik 5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8000" y="3240000"/>
            <a:ext cx="3510000" cy="2217600"/>
          </a:xfrm>
          <a:prstGeom prst="rect">
            <a:avLst/>
          </a:prstGeom>
        </p:spPr>
      </p:pic>
      <p:pic>
        <p:nvPicPr>
          <p:cNvPr id="2" name="Grafik 1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00" y="903600"/>
            <a:ext cx="3510000" cy="2217600"/>
          </a:xfrm>
          <a:prstGeom prst="rect">
            <a:avLst/>
          </a:prstGeom>
        </p:spPr>
      </p:pic>
      <p:pic>
        <p:nvPicPr>
          <p:cNvPr id="5" name="Grafik 4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8000" y="903600"/>
            <a:ext cx="3510000" cy="2217600"/>
          </a:xfrm>
          <a:prstGeom prst="rect">
            <a:avLst/>
          </a:prstGeom>
        </p:spPr>
      </p:pic>
      <p:pic>
        <p:nvPicPr>
          <p:cNvPr id="4" name="Grafik 3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00" y="5616000"/>
            <a:ext cx="3510000" cy="2217600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0" y="302552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smtClean="0">
                <a:latin typeface="Arial" panose="020B0604020202020204" pitchFamily="34" charset="0"/>
                <a:cs typeface="Arial" panose="020B0604020202020204" pitchFamily="34" charset="0"/>
              </a:rPr>
              <a:t> 1 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‒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uration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rombocytopeni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77264" y="75067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78800" y="308711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478800" y="545048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220227" y="780036"/>
            <a:ext cx="5083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All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atients                                         Older S-HAM vs. 1 Cycle Standard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246634" y="3105113"/>
            <a:ext cx="50585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  Younger                                         Older S-HAM vs. 2 Cycles Standard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259412" y="5468488"/>
            <a:ext cx="8734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itchFamily="34" charset="0"/>
                <a:cs typeface="Arial" pitchFamily="34" charset="0"/>
              </a:rPr>
              <a:t>   Older                                                                    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402222" y="7524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3402222" y="308711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14752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2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BB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raess</dc:creator>
  <cp:lastModifiedBy>Piette, Lauriane</cp:lastModifiedBy>
  <cp:revision>104</cp:revision>
  <cp:lastPrinted>2017-03-01T16:07:04Z</cp:lastPrinted>
  <dcterms:created xsi:type="dcterms:W3CDTF">2016-08-15T14:45:59Z</dcterms:created>
  <dcterms:modified xsi:type="dcterms:W3CDTF">2018-09-11T13:18:23Z</dcterms:modified>
</cp:coreProperties>
</file>